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5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45" d="100"/>
          <a:sy n="45" d="100"/>
        </p:scale>
        <p:origin x="1544" y="44"/>
      </p:cViewPr>
      <p:guideLst>
        <p:guide orient="horz" pos="307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0629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91191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10951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2519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88853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34313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06600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66569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56280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67573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9445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EB0589-260A-44FF-B4E8-1CED28753DFB}" type="datetimeFigureOut">
              <a:rPr lang="en-IN" smtClean="0"/>
              <a:t>01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36F85E-0CFD-46FC-9BDC-E79D876620D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74312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1.jpeg"/><Relationship Id="rId3" Type="http://schemas.openxmlformats.org/officeDocument/2006/relationships/image" Target="../media/image2.jpeg"/><Relationship Id="rId7" Type="http://schemas.openxmlformats.org/officeDocument/2006/relationships/image" Target="../media/image6.tiff"/><Relationship Id="rId12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pn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A7CA148D-7ED6-32D7-2E3E-FE6AD4D19369}"/>
              </a:ext>
            </a:extLst>
          </p:cNvPr>
          <p:cNvGrpSpPr/>
          <p:nvPr/>
        </p:nvGrpSpPr>
        <p:grpSpPr>
          <a:xfrm>
            <a:off x="635897" y="461965"/>
            <a:ext cx="2721272" cy="2998587"/>
            <a:chOff x="465756" y="2077597"/>
            <a:chExt cx="3094570" cy="3326112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D6288E5E-17F8-851F-0F3B-6F0C4DA97224}"/>
                </a:ext>
              </a:extLst>
            </p:cNvPr>
            <p:cNvGrpSpPr/>
            <p:nvPr/>
          </p:nvGrpSpPr>
          <p:grpSpPr>
            <a:xfrm>
              <a:off x="1105254" y="2947712"/>
              <a:ext cx="1236157" cy="2455997"/>
              <a:chOff x="8544406" y="1222470"/>
              <a:chExt cx="1051700" cy="2547804"/>
            </a:xfrm>
          </p:grpSpPr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028D090E-D67A-DC8B-63A2-E75BD0F3A204}"/>
                  </a:ext>
                </a:extLst>
              </p:cNvPr>
              <p:cNvPicPr/>
              <p:nvPr/>
            </p:nvPicPr>
            <p:blipFill rotWithShape="1">
              <a:blip r:embed="rId2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962" t="38640" r="35122" b="50699"/>
              <a:stretch>
                <a:fillRect/>
              </a:stretch>
            </p:blipFill>
            <p:spPr>
              <a:xfrm>
                <a:off x="8544406" y="2557741"/>
                <a:ext cx="1050239" cy="550177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7480365F-3EA0-1B38-5612-70C50ABEE693}"/>
                  </a:ext>
                </a:extLst>
              </p:cNvPr>
              <p:cNvPicPr/>
              <p:nvPr/>
            </p:nvPicPr>
            <p:blipFill rotWithShape="1">
              <a:blip r:embed="rId3" cstate="print">
                <a:duotone>
                  <a:prstClr val="black"/>
                  <a:schemeClr val="accent3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457" t="56929" r="39914" b="35075"/>
              <a:stretch>
                <a:fillRect/>
              </a:stretch>
            </p:blipFill>
            <p:spPr>
              <a:xfrm>
                <a:off x="8545867" y="1222470"/>
                <a:ext cx="1050239" cy="550177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958C955F-657C-0707-FBD9-CD7A4BB2A3B7}"/>
                  </a:ext>
                </a:extLst>
              </p:cNvPr>
              <p:cNvPicPr/>
              <p:nvPr/>
            </p:nvPicPr>
            <p:blipFill rotWithShape="1">
              <a:blip r:embed="rId4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482" t="56300" r="37963" b="34366"/>
              <a:stretch>
                <a:fillRect/>
              </a:stretch>
            </p:blipFill>
            <p:spPr>
              <a:xfrm>
                <a:off x="8544406" y="1889493"/>
                <a:ext cx="1050239" cy="550177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481023DC-CD3A-0857-19F3-4C9774CF4489}"/>
                  </a:ext>
                </a:extLst>
              </p:cNvPr>
              <p:cNvPicPr/>
              <p:nvPr/>
            </p:nvPicPr>
            <p:blipFill rotWithShape="1">
              <a:blip r:embed="rId5" cstate="print">
                <a:duotone>
                  <a:prstClr val="black"/>
                  <a:schemeClr val="accent3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2351" t="47395" r="31987" b="41056"/>
              <a:stretch>
                <a:fillRect/>
              </a:stretch>
            </p:blipFill>
            <p:spPr>
              <a:xfrm>
                <a:off x="8544406" y="3220097"/>
                <a:ext cx="1050239" cy="550177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</p:pic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2184BCD-1855-BA59-908C-BA248683590D}"/>
                </a:ext>
              </a:extLst>
            </p:cNvPr>
            <p:cNvSpPr txBox="1"/>
            <p:nvPr/>
          </p:nvSpPr>
          <p:spPr>
            <a:xfrm>
              <a:off x="2325270" y="3713563"/>
              <a:ext cx="963592" cy="290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err="1">
                  <a:latin typeface="Bell MT" panose="02020503060305020303" pitchFamily="18" charset="0"/>
                  <a:cs typeface="Times New Roman" panose="02020603050405020304" pitchFamily="18" charset="0"/>
                </a:rPr>
                <a:t>HuD</a:t>
              </a:r>
              <a:endParaRPr lang="en-US" sz="1100" b="1" dirty="0">
                <a:latin typeface="Bell MT" panose="02020503060305020303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4A83007-1621-3E11-54DF-6EED5D287BCD}"/>
                </a:ext>
              </a:extLst>
            </p:cNvPr>
            <p:cNvSpPr txBox="1"/>
            <p:nvPr/>
          </p:nvSpPr>
          <p:spPr>
            <a:xfrm>
              <a:off x="2332683" y="3058485"/>
              <a:ext cx="963592" cy="290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Bell MT" panose="02020503060305020303" pitchFamily="18" charset="0"/>
                  <a:cs typeface="Times New Roman" panose="02020603050405020304" pitchFamily="18" charset="0"/>
                </a:rPr>
                <a:t>Msi2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07D2DD7-64F3-ECBF-AFD9-2D58E4CA1DB1}"/>
                </a:ext>
              </a:extLst>
            </p:cNvPr>
            <p:cNvSpPr txBox="1"/>
            <p:nvPr/>
          </p:nvSpPr>
          <p:spPr>
            <a:xfrm>
              <a:off x="2307077" y="4387341"/>
              <a:ext cx="1192268" cy="290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Bell MT" panose="02020503060305020303" pitchFamily="18" charset="0"/>
                  <a:cs typeface="Times New Roman" panose="02020603050405020304" pitchFamily="18" charset="0"/>
                </a:rPr>
                <a:t>APAF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C592E63-F70C-3BA4-8D3F-758AC2CF6530}"/>
                </a:ext>
              </a:extLst>
            </p:cNvPr>
            <p:cNvSpPr txBox="1"/>
            <p:nvPr/>
          </p:nvSpPr>
          <p:spPr>
            <a:xfrm>
              <a:off x="2305532" y="5050265"/>
              <a:ext cx="1254794" cy="290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Bell MT" panose="02020503060305020303" pitchFamily="18" charset="0"/>
                  <a:cs typeface="Times New Roman" panose="02020603050405020304" pitchFamily="18" charset="0"/>
                </a:rPr>
                <a:t>Tubulin</a:t>
              </a:r>
            </a:p>
          </p:txBody>
        </p: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2D1D9C38-A700-C63D-CEAE-7BA1F0E8CBC8}"/>
                </a:ext>
              </a:extLst>
            </p:cNvPr>
            <p:cNvGrpSpPr/>
            <p:nvPr/>
          </p:nvGrpSpPr>
          <p:grpSpPr>
            <a:xfrm>
              <a:off x="465756" y="2077597"/>
              <a:ext cx="1949240" cy="932147"/>
              <a:chOff x="465756" y="2077597"/>
              <a:chExt cx="1949240" cy="932147"/>
            </a:xfrm>
          </p:grpSpPr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A5F0D895-32DF-D857-7E2F-5063CF133363}"/>
                  </a:ext>
                </a:extLst>
              </p:cNvPr>
              <p:cNvSpPr txBox="1"/>
              <p:nvPr/>
            </p:nvSpPr>
            <p:spPr>
              <a:xfrm>
                <a:off x="490520" y="2377486"/>
                <a:ext cx="1358913" cy="3004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 err="1">
                    <a:latin typeface="Bell MT" panose="02020503060305020303" pitchFamily="18" charset="0"/>
                    <a:cs typeface="Times New Roman" panose="02020603050405020304" pitchFamily="18" charset="0"/>
                  </a:rPr>
                  <a:t>siHuD</a:t>
                </a:r>
                <a:endParaRPr lang="en-US" sz="1100" b="1" dirty="0">
                  <a:latin typeface="Bell MT" panose="02020503060305020303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C8B80CB4-4796-FD63-D1FD-A3ED3D94B5E2}"/>
                  </a:ext>
                </a:extLst>
              </p:cNvPr>
              <p:cNvSpPr txBox="1"/>
              <p:nvPr/>
            </p:nvSpPr>
            <p:spPr>
              <a:xfrm>
                <a:off x="465756" y="2626242"/>
                <a:ext cx="1371266" cy="2901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latin typeface="Bell MT" panose="02020503060305020303" pitchFamily="18" charset="0"/>
                    <a:cs typeface="Times New Roman" panose="02020603050405020304" pitchFamily="18" charset="0"/>
                  </a:rPr>
                  <a:t>siMsi2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90B97DE3-EA44-51EF-E97B-F03C679EB4A1}"/>
                  </a:ext>
                </a:extLst>
              </p:cNvPr>
              <p:cNvSpPr txBox="1"/>
              <p:nvPr/>
            </p:nvSpPr>
            <p:spPr>
              <a:xfrm>
                <a:off x="1849433" y="2634211"/>
                <a:ext cx="359792" cy="3755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600" b="1" dirty="0"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94DE7B18-E083-14FA-C0F6-E8BD9837005A}"/>
                  </a:ext>
                </a:extLst>
              </p:cNvPr>
              <p:cNvSpPr txBox="1"/>
              <p:nvPr/>
            </p:nvSpPr>
            <p:spPr>
              <a:xfrm>
                <a:off x="1261546" y="2605898"/>
                <a:ext cx="539552" cy="3755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600" b="1" dirty="0">
                    <a:cs typeface="Times New Roman" panose="02020603050405020304" pitchFamily="18" charset="0"/>
                  </a:rPr>
                  <a:t>-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187B518F-E54F-4AAC-02DE-02550EF2778C}"/>
                  </a:ext>
                </a:extLst>
              </p:cNvPr>
              <p:cNvSpPr txBox="1"/>
              <p:nvPr/>
            </p:nvSpPr>
            <p:spPr>
              <a:xfrm>
                <a:off x="1861459" y="2354980"/>
                <a:ext cx="359792" cy="3755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600" b="1" dirty="0">
                    <a:cs typeface="Times New Roman" panose="02020603050405020304" pitchFamily="18" charset="0"/>
                  </a:rPr>
                  <a:t>+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07954C5C-B2CB-8918-106D-0B4AE4C8EAD0}"/>
                  </a:ext>
                </a:extLst>
              </p:cNvPr>
              <p:cNvSpPr txBox="1"/>
              <p:nvPr/>
            </p:nvSpPr>
            <p:spPr>
              <a:xfrm>
                <a:off x="679456" y="2137037"/>
                <a:ext cx="1319241" cy="2901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 err="1">
                    <a:latin typeface="Bell MT" panose="02020503060305020303" pitchFamily="18" charset="0"/>
                    <a:cs typeface="Times New Roman" panose="02020603050405020304" pitchFamily="18" charset="0"/>
                  </a:rPr>
                  <a:t>siC</a:t>
                </a:r>
                <a:endParaRPr lang="en-US" sz="1100" b="1" dirty="0">
                  <a:latin typeface="Bell MT" panose="02020503060305020303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C2B218BC-D689-F72B-8462-BF0DA70C278F}"/>
                  </a:ext>
                </a:extLst>
              </p:cNvPr>
              <p:cNvSpPr txBox="1"/>
              <p:nvPr/>
            </p:nvSpPr>
            <p:spPr>
              <a:xfrm>
                <a:off x="1875444" y="2077597"/>
                <a:ext cx="539552" cy="3755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600" b="1" dirty="0">
                    <a:cs typeface="Times New Roman" panose="02020603050405020304" pitchFamily="18" charset="0"/>
                  </a:rPr>
                  <a:t>-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452070E0-623E-963B-340A-B81E02B5F124}"/>
                  </a:ext>
                </a:extLst>
              </p:cNvPr>
              <p:cNvSpPr txBox="1"/>
              <p:nvPr/>
            </p:nvSpPr>
            <p:spPr>
              <a:xfrm>
                <a:off x="1252779" y="2331898"/>
                <a:ext cx="539552" cy="3755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600" b="1" dirty="0">
                    <a:cs typeface="Times New Roman" panose="02020603050405020304" pitchFamily="18" charset="0"/>
                  </a:rPr>
                  <a:t>-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7FA29A98-FE0B-8B72-8163-6D8F1AF94042}"/>
                  </a:ext>
                </a:extLst>
              </p:cNvPr>
              <p:cNvSpPr txBox="1"/>
              <p:nvPr/>
            </p:nvSpPr>
            <p:spPr>
              <a:xfrm>
                <a:off x="1252779" y="2077597"/>
                <a:ext cx="359792" cy="3755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600" b="1" dirty="0">
                    <a:cs typeface="Times New Roman" panose="02020603050405020304" pitchFamily="18" charset="0"/>
                  </a:rPr>
                  <a:t>+</a:t>
                </a:r>
              </a:p>
            </p:txBody>
          </p:sp>
        </p:grpSp>
      </p:grpSp>
      <p:pic>
        <p:nvPicPr>
          <p:cNvPr id="24" name="Picture 23">
            <a:extLst>
              <a:ext uri="{FF2B5EF4-FFF2-40B4-BE49-F238E27FC236}">
                <a16:creationId xmlns:a16="http://schemas.microsoft.com/office/drawing/2014/main" id="{2573593B-D6A1-BFB1-BD29-A3202E866F77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287" r="3380"/>
          <a:stretch>
            <a:fillRect/>
          </a:stretch>
        </p:blipFill>
        <p:spPr>
          <a:xfrm>
            <a:off x="3132815" y="672871"/>
            <a:ext cx="3535893" cy="3112680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F5C7FCBA-1191-708E-28DE-6F53296283FE}"/>
              </a:ext>
            </a:extLst>
          </p:cNvPr>
          <p:cNvGrpSpPr/>
          <p:nvPr/>
        </p:nvGrpSpPr>
        <p:grpSpPr>
          <a:xfrm>
            <a:off x="3037410" y="4510943"/>
            <a:ext cx="3698931" cy="3112223"/>
            <a:chOff x="3017544" y="4937287"/>
            <a:chExt cx="3698931" cy="3254196"/>
          </a:xfrm>
        </p:grpSpPr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D2CED687-E57F-40C0-24F3-FD2729C7F9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7493" r="15201"/>
            <a:stretch/>
          </p:blipFill>
          <p:spPr>
            <a:xfrm>
              <a:off x="3017544" y="5129523"/>
              <a:ext cx="3698931" cy="3061960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B9ABD8FA-8AF6-60B2-9994-53672A672F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806" t="24768" r="3380" b="63762"/>
            <a:stretch/>
          </p:blipFill>
          <p:spPr>
            <a:xfrm>
              <a:off x="5296040" y="4937287"/>
              <a:ext cx="1420435" cy="436263"/>
            </a:xfrm>
            <a:prstGeom prst="rect">
              <a:avLst/>
            </a:prstGeom>
          </p:spPr>
        </p:pic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FF7592C2-5904-A8A9-540F-2409F5331922}"/>
              </a:ext>
            </a:extLst>
          </p:cNvPr>
          <p:cNvSpPr txBox="1"/>
          <p:nvPr/>
        </p:nvSpPr>
        <p:spPr>
          <a:xfrm>
            <a:off x="332320" y="179568"/>
            <a:ext cx="4147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Bell MT" panose="02020503060305020303" pitchFamily="18" charset="0"/>
              </a:rPr>
              <a:t>A.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766AB7B-63A3-B229-F63C-FBA189417C43}"/>
              </a:ext>
            </a:extLst>
          </p:cNvPr>
          <p:cNvSpPr txBox="1"/>
          <p:nvPr/>
        </p:nvSpPr>
        <p:spPr>
          <a:xfrm>
            <a:off x="326205" y="5121789"/>
            <a:ext cx="4147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Bell MT" panose="02020503060305020303" pitchFamily="18" charset="0"/>
              </a:rPr>
              <a:t>B.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766AB7B-63A3-B229-F63C-FBA189417C43}"/>
              </a:ext>
            </a:extLst>
          </p:cNvPr>
          <p:cNvSpPr txBox="1"/>
          <p:nvPr/>
        </p:nvSpPr>
        <p:spPr>
          <a:xfrm>
            <a:off x="440605" y="4948003"/>
            <a:ext cx="4147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Bell MT" panose="02020503060305020303" pitchFamily="18" charset="0"/>
              </a:rPr>
              <a:t>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2A54D5F-5112-CF5C-A108-29733BC344CD}"/>
              </a:ext>
            </a:extLst>
          </p:cNvPr>
          <p:cNvGrpSpPr/>
          <p:nvPr/>
        </p:nvGrpSpPr>
        <p:grpSpPr>
          <a:xfrm>
            <a:off x="440605" y="4015867"/>
            <a:ext cx="3174516" cy="4249844"/>
            <a:chOff x="587931" y="1118172"/>
            <a:chExt cx="3215001" cy="4583333"/>
          </a:xfrm>
        </p:grpSpPr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4B0385BB-CB78-2630-026E-6B47556555C0}"/>
                </a:ext>
              </a:extLst>
            </p:cNvPr>
            <p:cNvPicPr/>
            <p:nvPr/>
          </p:nvPicPr>
          <p:blipFill rotWithShape="1">
            <a:blip r:embed="rId8" cstate="print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979" t="45826" r="46894" b="46416"/>
            <a:stretch>
              <a:fillRect/>
            </a:stretch>
          </p:blipFill>
          <p:spPr>
            <a:xfrm>
              <a:off x="1227743" y="4557647"/>
              <a:ext cx="1234440" cy="53035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0E0FE4E9-BFA2-764F-1AB8-AC97BC09210A}"/>
                </a:ext>
              </a:extLst>
            </p:cNvPr>
            <p:cNvPicPr/>
            <p:nvPr/>
          </p:nvPicPr>
          <p:blipFill rotWithShape="1">
            <a:blip r:embed="rId9" cstate="print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42" t="36093" r="47852" b="53819"/>
            <a:stretch>
              <a:fillRect/>
            </a:stretch>
          </p:blipFill>
          <p:spPr>
            <a:xfrm>
              <a:off x="1227743" y="3944141"/>
              <a:ext cx="1234440" cy="53035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id="{3D8429EB-61C5-DA12-664D-0AFE03BB8606}"/>
                </a:ext>
              </a:extLst>
            </p:cNvPr>
            <p:cNvPicPr/>
            <p:nvPr/>
          </p:nvPicPr>
          <p:blipFill rotWithShape="1">
            <a:blip r:embed="rId10" cstate="print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986" t="15870" r="51178" b="77446"/>
            <a:stretch>
              <a:fillRect/>
            </a:stretch>
          </p:blipFill>
          <p:spPr>
            <a:xfrm>
              <a:off x="1227743" y="5171153"/>
              <a:ext cx="1234440" cy="53035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id="{17A0DEF9-5FB8-E296-47B5-DD651755A2C2}"/>
                </a:ext>
              </a:extLst>
            </p:cNvPr>
            <p:cNvPicPr/>
            <p:nvPr/>
          </p:nvPicPr>
          <p:blipFill rotWithShape="1">
            <a:blip r:embed="rId11" cstate="hq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479" t="33359" r="48235" b="59422"/>
            <a:stretch>
              <a:fillRect/>
            </a:stretch>
          </p:blipFill>
          <p:spPr>
            <a:xfrm>
              <a:off x="1227743" y="2118577"/>
              <a:ext cx="1234440" cy="53035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C485CD9E-BCC3-FE7F-BDF5-E09C91037347}"/>
                </a:ext>
              </a:extLst>
            </p:cNvPr>
            <p:cNvPicPr/>
            <p:nvPr/>
          </p:nvPicPr>
          <p:blipFill rotWithShape="1">
            <a:blip r:embed="rId13" cstate="print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036" t="38313" r="47641" b="52846"/>
            <a:stretch>
              <a:fillRect/>
            </a:stretch>
          </p:blipFill>
          <p:spPr>
            <a:xfrm>
              <a:off x="1227743" y="3330635"/>
              <a:ext cx="1234440" cy="53035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6895C1C5-7977-64B6-AED8-78762249C2E8}"/>
                </a:ext>
              </a:extLst>
            </p:cNvPr>
            <p:cNvPicPr/>
            <p:nvPr/>
          </p:nvPicPr>
          <p:blipFill rotWithShape="1">
            <a:blip r:embed="rId14" cstate="print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474" t="20798" r="41363" b="71424"/>
            <a:stretch>
              <a:fillRect/>
            </a:stretch>
          </p:blipFill>
          <p:spPr>
            <a:xfrm>
              <a:off x="1227743" y="2717129"/>
              <a:ext cx="1234440" cy="53035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127492F5-1333-0074-9293-8BC28378ABC7}"/>
                </a:ext>
              </a:extLst>
            </p:cNvPr>
            <p:cNvGrpSpPr/>
            <p:nvPr/>
          </p:nvGrpSpPr>
          <p:grpSpPr>
            <a:xfrm>
              <a:off x="587931" y="1118172"/>
              <a:ext cx="2007969" cy="1030100"/>
              <a:chOff x="419766" y="2042974"/>
              <a:chExt cx="2007969" cy="1030100"/>
            </a:xfrm>
          </p:grpSpPr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AD145641-B1E8-A9CB-0A78-1A8202987F7E}"/>
                  </a:ext>
                </a:extLst>
              </p:cNvPr>
              <p:cNvSpPr txBox="1"/>
              <p:nvPr/>
            </p:nvSpPr>
            <p:spPr>
              <a:xfrm>
                <a:off x="1872255" y="2707954"/>
                <a:ext cx="359792" cy="3651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600" b="1" dirty="0"/>
                  <a:t>+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5B307010-EEE0-0D55-729F-283E8BC78B7D}"/>
                  </a:ext>
                </a:extLst>
              </p:cNvPr>
              <p:cNvSpPr txBox="1"/>
              <p:nvPr/>
            </p:nvSpPr>
            <p:spPr>
              <a:xfrm>
                <a:off x="1267232" y="2704836"/>
                <a:ext cx="539552" cy="3651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600" b="1" dirty="0"/>
                  <a:t>-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69ECD5DF-6699-E1C8-DA2A-F87F74CBBBBD}"/>
                  </a:ext>
                </a:extLst>
              </p:cNvPr>
              <p:cNvSpPr txBox="1"/>
              <p:nvPr/>
            </p:nvSpPr>
            <p:spPr>
              <a:xfrm>
                <a:off x="1879973" y="2403138"/>
                <a:ext cx="359792" cy="3651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600" b="1" dirty="0"/>
                  <a:t>+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23B1B2B2-79EF-CA4C-3E37-B571749C151B}"/>
                  </a:ext>
                </a:extLst>
              </p:cNvPr>
              <p:cNvSpPr txBox="1"/>
              <p:nvPr/>
            </p:nvSpPr>
            <p:spPr>
              <a:xfrm>
                <a:off x="419766" y="2117101"/>
                <a:ext cx="1319241" cy="2801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latin typeface="Bell MT" panose="02020503060305020303" pitchFamily="18" charset="0"/>
                    <a:cs typeface="Times New Roman" panose="02020603050405020304" pitchFamily="18" charset="0"/>
                  </a:rPr>
                  <a:t>C siRNA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D4A8F371-1022-AA01-A694-0F609745BDF2}"/>
                  </a:ext>
                </a:extLst>
              </p:cNvPr>
              <p:cNvSpPr txBox="1"/>
              <p:nvPr/>
            </p:nvSpPr>
            <p:spPr>
              <a:xfrm>
                <a:off x="1888183" y="2042974"/>
                <a:ext cx="539552" cy="3651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600" b="1" dirty="0"/>
                  <a:t>-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B58140AF-7D7F-EEB0-DE8B-EBDE30E53F6D}"/>
                  </a:ext>
                </a:extLst>
              </p:cNvPr>
              <p:cNvSpPr txBox="1"/>
              <p:nvPr/>
            </p:nvSpPr>
            <p:spPr>
              <a:xfrm>
                <a:off x="1274950" y="2408449"/>
                <a:ext cx="539552" cy="3651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600" b="1" dirty="0"/>
                  <a:t>-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ED32F412-FFDF-D3A1-BF91-3C7455272538}"/>
                  </a:ext>
                </a:extLst>
              </p:cNvPr>
              <p:cNvSpPr txBox="1"/>
              <p:nvPr/>
            </p:nvSpPr>
            <p:spPr>
              <a:xfrm>
                <a:off x="1263743" y="2076937"/>
                <a:ext cx="359792" cy="3651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600" b="1" dirty="0"/>
                  <a:t>+</a:t>
                </a:r>
              </a:p>
            </p:txBody>
          </p:sp>
        </p:grp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768F8CF7-80A8-56A0-D003-88C0B350F2C7}"/>
                </a:ext>
              </a:extLst>
            </p:cNvPr>
            <p:cNvSpPr txBox="1"/>
            <p:nvPr/>
          </p:nvSpPr>
          <p:spPr>
            <a:xfrm>
              <a:off x="2462183" y="2224855"/>
              <a:ext cx="963592" cy="2821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Bell MT" panose="02020503060305020303" pitchFamily="18" charset="0"/>
                  <a:cs typeface="Times New Roman" panose="02020603050405020304" pitchFamily="18" charset="0"/>
                </a:rPr>
                <a:t>Msi2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5E444D91-BA0F-B08F-D101-6B6C32496FF9}"/>
                </a:ext>
              </a:extLst>
            </p:cNvPr>
            <p:cNvSpPr txBox="1"/>
            <p:nvPr/>
          </p:nvSpPr>
          <p:spPr>
            <a:xfrm>
              <a:off x="2462183" y="2838361"/>
              <a:ext cx="963592" cy="2821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err="1">
                  <a:latin typeface="Bell MT" panose="02020503060305020303" pitchFamily="18" charset="0"/>
                  <a:cs typeface="Times New Roman" panose="02020603050405020304" pitchFamily="18" charset="0"/>
                </a:rPr>
                <a:t>HuD</a:t>
              </a:r>
              <a:endParaRPr lang="en-US" sz="1100" b="1" dirty="0">
                <a:latin typeface="Bell MT" panose="02020503060305020303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9A3766C-37FA-E6BC-7309-6ABA9027A016}"/>
                </a:ext>
              </a:extLst>
            </p:cNvPr>
            <p:cNvSpPr txBox="1"/>
            <p:nvPr/>
          </p:nvSpPr>
          <p:spPr>
            <a:xfrm>
              <a:off x="2462183" y="3436913"/>
              <a:ext cx="1340749" cy="2821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Bell MT" panose="02020503060305020303" pitchFamily="18" charset="0"/>
                  <a:cs typeface="Times New Roman" panose="02020603050405020304" pitchFamily="18" charset="0"/>
                </a:rPr>
                <a:t>Procasp-3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4CC4AE7A-A823-2F02-7644-FF91311517BB}"/>
                </a:ext>
              </a:extLst>
            </p:cNvPr>
            <p:cNvSpPr txBox="1"/>
            <p:nvPr/>
          </p:nvSpPr>
          <p:spPr>
            <a:xfrm>
              <a:off x="2462182" y="4046371"/>
              <a:ext cx="1340749" cy="2821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err="1">
                  <a:latin typeface="Bell MT" panose="02020503060305020303" pitchFamily="18" charset="0"/>
                  <a:cs typeface="Times New Roman" panose="02020603050405020304" pitchFamily="18" charset="0"/>
                </a:rPr>
                <a:t>Bax</a:t>
              </a:r>
              <a:endParaRPr lang="en-US" sz="1100" b="1" dirty="0">
                <a:latin typeface="Bell MT" panose="02020503060305020303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2F17F842-1FE9-11D9-DDE7-5429163105EF}"/>
                </a:ext>
              </a:extLst>
            </p:cNvPr>
            <p:cNvSpPr txBox="1"/>
            <p:nvPr/>
          </p:nvSpPr>
          <p:spPr>
            <a:xfrm>
              <a:off x="2462181" y="4659877"/>
              <a:ext cx="1340749" cy="2821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Bell MT" panose="02020503060305020303" pitchFamily="18" charset="0"/>
                  <a:cs typeface="Times New Roman" panose="02020603050405020304" pitchFamily="18" charset="0"/>
                </a:rPr>
                <a:t>Bcl2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1BB8EEF3-37A1-DC4D-839C-4DD92C7F3445}"/>
                </a:ext>
              </a:extLst>
            </p:cNvPr>
            <p:cNvSpPr txBox="1"/>
            <p:nvPr/>
          </p:nvSpPr>
          <p:spPr>
            <a:xfrm>
              <a:off x="2462181" y="5273383"/>
              <a:ext cx="862712" cy="2821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Bell MT" panose="02020503060305020303" pitchFamily="18" charset="0"/>
                  <a:cs typeface="Times New Roman" panose="02020603050405020304" pitchFamily="18" charset="0"/>
                </a:rPr>
                <a:t>GAPDH</a:t>
              </a:r>
            </a:p>
          </p:txBody>
        </p:sp>
      </p:grpSp>
      <p:sp>
        <p:nvSpPr>
          <p:cNvPr id="74" name="TextBox 73">
            <a:extLst>
              <a:ext uri="{FF2B5EF4-FFF2-40B4-BE49-F238E27FC236}">
                <a16:creationId xmlns:a16="http://schemas.microsoft.com/office/drawing/2014/main" id="{58599D4E-3D46-5044-2D48-0D0CE7C4B06B}"/>
              </a:ext>
            </a:extLst>
          </p:cNvPr>
          <p:cNvSpPr txBox="1"/>
          <p:nvPr/>
        </p:nvSpPr>
        <p:spPr>
          <a:xfrm>
            <a:off x="503616" y="4378073"/>
            <a:ext cx="1194987" cy="270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>
                <a:latin typeface="Bell MT" panose="02020503060305020303" pitchFamily="18" charset="0"/>
                <a:cs typeface="Times New Roman" panose="02020603050405020304" pitchFamily="18" charset="0"/>
              </a:rPr>
              <a:t>siHuD</a:t>
            </a:r>
            <a:endParaRPr lang="en-US" sz="1100" b="1" dirty="0">
              <a:latin typeface="Bell MT" panose="02020503060305020303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8880F0A-92D6-9CFA-39DB-A3FF18E468AB}"/>
              </a:ext>
            </a:extLst>
          </p:cNvPr>
          <p:cNvSpPr txBox="1"/>
          <p:nvPr/>
        </p:nvSpPr>
        <p:spPr>
          <a:xfrm>
            <a:off x="481808" y="4686928"/>
            <a:ext cx="1205850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Bell MT" panose="02020503060305020303" pitchFamily="18" charset="0"/>
                <a:cs typeface="Times New Roman" panose="02020603050405020304" pitchFamily="18" charset="0"/>
              </a:rPr>
              <a:t>siMsi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E2D2F1B-E1F2-EA7B-9DF4-BD1F372F845D}"/>
              </a:ext>
            </a:extLst>
          </p:cNvPr>
          <p:cNvSpPr txBox="1"/>
          <p:nvPr/>
        </p:nvSpPr>
        <p:spPr>
          <a:xfrm>
            <a:off x="186118" y="8357671"/>
            <a:ext cx="6433045" cy="14477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 Fig 3: </a:t>
            </a:r>
            <a:r>
              <a:rPr lang="en-US" sz="1200" b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D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Msi2 double knockdown does not causes additive increase in the APAF1 levels and </a:t>
            </a:r>
            <a:r>
              <a:rPr lang="en-US" sz="1200" b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x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Bcl2 ratio.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uble knockdown of </a:t>
            </a:r>
            <a:r>
              <a:rPr lang="en-US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D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Msi2 was carried out in N2a cells using siRNA, the protein levels of APAF1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ratio of </a:t>
            </a:r>
            <a:r>
              <a:rPr lang="en-US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x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/Bcl2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ere analyzed by western blotting. Western blot showing increase in the protein levels of APAF1 upon </a:t>
            </a:r>
            <a:r>
              <a:rPr lang="en-US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uD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Msi2 double knockdown and its graphical representation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(right panel)</a:t>
            </a:r>
            <a:endParaRPr lang="en-IN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B2B2613-548A-A897-AB1B-0C255BDB03DD}"/>
              </a:ext>
            </a:extLst>
          </p:cNvPr>
          <p:cNvSpPr txBox="1"/>
          <p:nvPr/>
        </p:nvSpPr>
        <p:spPr>
          <a:xfrm>
            <a:off x="5711986" y="50521"/>
            <a:ext cx="11797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IN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aikwad</a:t>
            </a:r>
            <a:r>
              <a:rPr lang="en-IN" sz="1200" i="1" dirty="0">
                <a:latin typeface="Arial" panose="020B0604020202020204" pitchFamily="34" charset="0"/>
                <a:cs typeface="Arial" panose="020B0604020202020204" pitchFamily="34" charset="0"/>
              </a:rPr>
              <a:t> et al. </a:t>
            </a:r>
          </a:p>
        </p:txBody>
      </p:sp>
    </p:spTree>
    <p:extLst>
      <p:ext uri="{BB962C8B-B14F-4D97-AF65-F5344CB8AC3E}">
        <p14:creationId xmlns:p14="http://schemas.microsoft.com/office/powerpoint/2010/main" val="3781050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1</TotalTime>
  <Words>125</Words>
  <Application>Microsoft Office PowerPoint</Application>
  <PresentationFormat>A4 Paper (210x297 mm)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Bell MT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ina gaikwad</dc:creator>
  <cp:lastModifiedBy>comp support</cp:lastModifiedBy>
  <cp:revision>23</cp:revision>
  <dcterms:created xsi:type="dcterms:W3CDTF">2022-09-05T06:06:19Z</dcterms:created>
  <dcterms:modified xsi:type="dcterms:W3CDTF">2024-12-01T12:27:06Z</dcterms:modified>
</cp:coreProperties>
</file>